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124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630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3D20D9-09F3-420D-85E3-892D47278E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A94824E-C1D9-4C98-AE14-28D46BE37D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589516-CB87-484B-9D6F-65B4B7A3A2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9EFD0-C4A9-4BB9-A5DB-76CA8879728C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955983-4AD3-4594-B682-FF4F21AA95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374B5F-0813-40C1-A62E-2C9B396C54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7A064-029D-48E8-9848-CF92DE25C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906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9972D4-B46A-4888-8314-96BE90188E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961708-8817-409D-8A48-5CE5152DF2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ED837B-D725-40B5-879A-AC7EF38F2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9EFD0-C4A9-4BB9-A5DB-76CA8879728C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4D5E0E-5BFA-45DF-9C06-1EAE32BA59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C82580-0F07-4384-93F2-8351DA7E15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7A064-029D-48E8-9848-CF92DE25C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0877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C8EB8A8-E995-4AD0-AEAD-57A1783F50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E3F5BA-4DC8-4498-A114-C041F8251A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7268AD-AAFE-4143-9F83-917DB0105D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9EFD0-C4A9-4BB9-A5DB-76CA8879728C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658058-5514-42E6-9542-AD2ABB4E1A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C105AE-48D9-4601-83B9-B3A3AB9D8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7A064-029D-48E8-9848-CF92DE25C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3722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4F05D0-D721-4A74-A434-51D8442AAA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D38114-489D-4205-9CF7-C421912EC7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162BD4-AF10-4F72-93CB-29830043A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9EFD0-C4A9-4BB9-A5DB-76CA8879728C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52E640-6E29-47F2-815E-D72E06A3A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AE00C1-F739-44EC-96AB-B47A4BC568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7A064-029D-48E8-9848-CF92DE25C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319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2DF515-E05D-4CFB-8FE3-DBC64DAD54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F45936-B0C1-444B-8DE3-E54F669F2F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59C005-AF3E-47F6-9B7B-7BE4054E90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9EFD0-C4A9-4BB9-A5DB-76CA8879728C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C39753-C8FA-4509-BF16-8FF7BE7D6C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26A588-D181-4528-B220-24D01F424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7A064-029D-48E8-9848-CF92DE25C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769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C9E693-FEDF-43AD-913C-1D937C00E5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481B5C-5DFC-4972-804A-6033C0D7B00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C31B2E-FB32-40B2-AC17-C085BD5D96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881F60-0239-44A7-B530-4F308A44C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9EFD0-C4A9-4BB9-A5DB-76CA8879728C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2BE0C7-FCA0-416E-B19F-379EB73468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D5504D-D328-4728-B0D0-B6722D7ED4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7A064-029D-48E8-9848-CF92DE25C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289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EBF309-7D51-42A2-9E1A-43A7986193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6BF8D0-B90F-41DB-8857-86E9E7AFAE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E9F154-733D-440E-8F06-28C861C418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46EFE4-C16D-4E36-A08F-7F6AABEE4C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02D71EE-72B6-4B64-A53C-37AFB77E80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787CC6D-89A1-4D98-BD4E-6E1FDB278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9EFD0-C4A9-4BB9-A5DB-76CA8879728C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C09BD01-4CD1-4A48-B976-9A1488733E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2997CA4-8843-4BE9-87C0-E88BB6826D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7A064-029D-48E8-9848-CF92DE25C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335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74C30C-1B9B-4926-A251-EEF5D34965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7010A35-BC7B-4EA1-8E50-C6163F3289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9EFD0-C4A9-4BB9-A5DB-76CA8879728C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36039C1-DA79-4C59-A22D-D395EACF8B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BB0582-0167-4E9C-BB62-093D70A005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7A064-029D-48E8-9848-CF92DE25C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192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8217CF9-8CCD-48D1-BE71-E090DDD84E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9EFD0-C4A9-4BB9-A5DB-76CA8879728C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55740D7-7290-4D6E-BD0B-7A18F4DD86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C5BD434-5EF9-4DA6-90CD-21717DE401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7A064-029D-48E8-9848-CF92DE25C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993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3BA322-4EAA-4FD1-97BB-38E9EE5366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BEC8D8-14DA-4775-9AB5-75798D92A9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D569DD-8315-41FA-8DAA-F8B6DF50EA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A71F71-FBA0-4BEF-99EC-32CBB3EAE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9EFD0-C4A9-4BB9-A5DB-76CA8879728C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6E4DAB-6894-45DB-95CF-7495AF42F1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0A5FB6-F72A-4AF5-8157-53700E0D75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7A064-029D-48E8-9848-CF92DE25C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294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C22520-84C3-4E19-A896-22586E8750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A8C4A46-CC68-40C7-9DF2-01CF97E0B0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EF4D06-39AA-4559-A57E-3FA0E4B731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F14B62-F21B-46E8-85BB-0FBBD7CD8B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9EFD0-C4A9-4BB9-A5DB-76CA8879728C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EDD87B-271F-491A-BCBA-3B6C91E491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8BD16C-1544-4C6D-A0F9-6E5276FA6C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7A064-029D-48E8-9848-CF92DE25C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978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BFF142F-60EE-4DA6-B6D4-C2702510C5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646B72-1A2D-4870-866D-E9983D703F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DB3906-24E7-4C66-940C-9A76C99A83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79EFD0-C4A9-4BB9-A5DB-76CA8879728C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CB8668-CC18-4658-940C-39EB5E84B80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1BF84B-AA33-485B-84ED-D8404D1FE6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57A064-029D-48E8-9848-CF92DE25C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682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2EFEDB78-9EB8-4434-94F7-7D7A393E9933}"/>
              </a:ext>
            </a:extLst>
          </p:cNvPr>
          <p:cNvGrpSpPr/>
          <p:nvPr/>
        </p:nvGrpSpPr>
        <p:grpSpPr>
          <a:xfrm>
            <a:off x="1038519" y="294641"/>
            <a:ext cx="10141206" cy="6157479"/>
            <a:chOff x="1615905" y="117087"/>
            <a:chExt cx="10141206" cy="6157479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C9EC17C7-2C98-41E2-B5DF-C82A98C87FFD}"/>
                </a:ext>
              </a:extLst>
            </p:cNvPr>
            <p:cNvGrpSpPr/>
            <p:nvPr/>
          </p:nvGrpSpPr>
          <p:grpSpPr>
            <a:xfrm>
              <a:off x="7893656" y="2246327"/>
              <a:ext cx="3863455" cy="4028239"/>
              <a:chOff x="8189747" y="3117184"/>
              <a:chExt cx="3863455" cy="4028239"/>
            </a:xfrm>
          </p:grpSpPr>
          <p:pic>
            <p:nvPicPr>
              <p:cNvPr id="49" name="Picture 48" descr="A picture containing text, plant, leaf&#10;&#10;Description automatically generated">
                <a:extLst>
                  <a:ext uri="{FF2B5EF4-FFF2-40B4-BE49-F238E27FC236}">
                    <a16:creationId xmlns:a16="http://schemas.microsoft.com/office/drawing/2014/main" id="{52D9A3B5-DC3E-471A-B67E-A34E992ED4E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189747" y="3117184"/>
                <a:ext cx="3667637" cy="1076475"/>
              </a:xfrm>
              <a:prstGeom prst="rect">
                <a:avLst/>
              </a:prstGeom>
            </p:spPr>
          </p:pic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8163CEFD-324D-49FB-8D37-EFA48FCFAC8C}"/>
                  </a:ext>
                </a:extLst>
              </p:cNvPr>
              <p:cNvSpPr txBox="1"/>
              <p:nvPr/>
            </p:nvSpPr>
            <p:spPr>
              <a:xfrm>
                <a:off x="9544584" y="4127861"/>
                <a:ext cx="18469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Prepared RNA-Seq libraries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F9118154-731B-4A8D-B359-2A7BED262F0A}"/>
                  </a:ext>
                </a:extLst>
              </p:cNvPr>
              <p:cNvSpPr txBox="1"/>
              <p:nvPr/>
            </p:nvSpPr>
            <p:spPr>
              <a:xfrm>
                <a:off x="8364570" y="4193179"/>
                <a:ext cx="132279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RNA extraction:</a:t>
                </a:r>
              </a:p>
              <a:p>
                <a:r>
                  <a:rPr lang="en-US" sz="12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(Ca, Cg, and Mock)</a:t>
                </a:r>
              </a:p>
            </p:txBody>
          </p:sp>
          <p:sp>
            <p:nvSpPr>
              <p:cNvPr id="52" name="Rectangle: Rounded Corners 51">
                <a:extLst>
                  <a:ext uri="{FF2B5EF4-FFF2-40B4-BE49-F238E27FC236}">
                    <a16:creationId xmlns:a16="http://schemas.microsoft.com/office/drawing/2014/main" id="{15613E2D-7086-4922-9C1F-77796DD4D2C0}"/>
                  </a:ext>
                </a:extLst>
              </p:cNvPr>
              <p:cNvSpPr/>
              <p:nvPr/>
            </p:nvSpPr>
            <p:spPr>
              <a:xfrm>
                <a:off x="9675222" y="4380410"/>
                <a:ext cx="522506" cy="235132"/>
              </a:xfrm>
              <a:prstGeom prst="roundRect">
                <a:avLst/>
              </a:prstGeom>
              <a:solidFill>
                <a:srgbClr val="00B0F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0 </a:t>
                </a:r>
                <a:r>
                  <a:rPr lang="en-US" sz="800" b="1" dirty="0" err="1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hpi</a:t>
                </a:r>
                <a:endParaRPr lang="en-US" sz="800" b="1" dirty="0">
                  <a:solidFill>
                    <a:schemeClr val="tx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53" name="Rectangle: Rounded Corners 52">
                <a:extLst>
                  <a:ext uri="{FF2B5EF4-FFF2-40B4-BE49-F238E27FC236}">
                    <a16:creationId xmlns:a16="http://schemas.microsoft.com/office/drawing/2014/main" id="{4DE8273F-6C82-43D2-9BE7-19819C450E7F}"/>
                  </a:ext>
                </a:extLst>
              </p:cNvPr>
              <p:cNvSpPr/>
              <p:nvPr/>
            </p:nvSpPr>
            <p:spPr>
              <a:xfrm>
                <a:off x="10215147" y="4371703"/>
                <a:ext cx="478980" cy="252547"/>
              </a:xfrm>
              <a:prstGeom prst="roundRect">
                <a:avLst/>
              </a:prstGeom>
              <a:solidFill>
                <a:srgbClr val="FF00FF"/>
              </a:solidFill>
              <a:ln>
                <a:solidFill>
                  <a:srgbClr val="FF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solidFill>
                      <a:schemeClr val="tx1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24 </a:t>
                </a:r>
                <a:r>
                  <a:rPr lang="en-US" sz="800" b="1" dirty="0" err="1">
                    <a:solidFill>
                      <a:schemeClr val="tx1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hpi</a:t>
                </a:r>
                <a:endParaRPr lang="en-US" sz="800" b="1" dirty="0">
                  <a:solidFill>
                    <a:schemeClr val="tx1"/>
                  </a:solidFill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Rectangle: Rounded Corners 53">
                <a:extLst>
                  <a:ext uri="{FF2B5EF4-FFF2-40B4-BE49-F238E27FC236}">
                    <a16:creationId xmlns:a16="http://schemas.microsoft.com/office/drawing/2014/main" id="{20A6ACE6-B7C8-419A-A5C5-A4E6578A4132}"/>
                  </a:ext>
                </a:extLst>
              </p:cNvPr>
              <p:cNvSpPr/>
              <p:nvPr/>
            </p:nvSpPr>
            <p:spPr>
              <a:xfrm>
                <a:off x="10711534" y="4362993"/>
                <a:ext cx="478981" cy="261258"/>
              </a:xfrm>
              <a:prstGeom prst="roundRect">
                <a:avLst/>
              </a:prstGeom>
              <a:solidFill>
                <a:srgbClr val="FFC000"/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800" b="1" dirty="0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48  </a:t>
                </a:r>
                <a:r>
                  <a:rPr lang="en-US" sz="800" b="1" dirty="0" err="1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hpi</a:t>
                </a:r>
                <a:endParaRPr lang="en-US" sz="800" b="1" dirty="0">
                  <a:solidFill>
                    <a:schemeClr val="tx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3CAC87DA-B9FA-4C8E-8B6F-CE84381927C8}"/>
                  </a:ext>
                </a:extLst>
              </p:cNvPr>
              <p:cNvSpPr txBox="1"/>
              <p:nvPr/>
            </p:nvSpPr>
            <p:spPr>
              <a:xfrm>
                <a:off x="11129551" y="4319451"/>
                <a:ext cx="9236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 Narrow" panose="020B0606020202030204" pitchFamily="34" charset="0"/>
                  </a:rPr>
                  <a:t>3 Replicates</a:t>
                </a:r>
              </a:p>
            </p:txBody>
          </p:sp>
          <p:pic>
            <p:nvPicPr>
              <p:cNvPr id="56" name="Picture 55" descr="Diagram&#10;&#10;Description automatically generated">
                <a:extLst>
                  <a:ext uri="{FF2B5EF4-FFF2-40B4-BE49-F238E27FC236}">
                    <a16:creationId xmlns:a16="http://schemas.microsoft.com/office/drawing/2014/main" id="{3B9E3C54-AB81-4B72-8C21-0DFC6EA7889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397195" y="4659051"/>
                <a:ext cx="2419688" cy="2486372"/>
              </a:xfrm>
              <a:prstGeom prst="rect">
                <a:avLst/>
              </a:prstGeom>
            </p:spPr>
          </p:pic>
        </p:grp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F0C4B6D2-8886-4CEC-AAFE-C0C1606FA1D2}"/>
                </a:ext>
              </a:extLst>
            </p:cNvPr>
            <p:cNvSpPr/>
            <p:nvPr/>
          </p:nvSpPr>
          <p:spPr>
            <a:xfrm>
              <a:off x="7698376" y="905691"/>
              <a:ext cx="4058194" cy="5329646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9D4BC382-BB1E-4904-A74D-984EF2ED6C01}"/>
                </a:ext>
              </a:extLst>
            </p:cNvPr>
            <p:cNvGrpSpPr/>
            <p:nvPr/>
          </p:nvGrpSpPr>
          <p:grpSpPr>
            <a:xfrm>
              <a:off x="1615905" y="117087"/>
              <a:ext cx="8477956" cy="2817531"/>
              <a:chOff x="852425" y="125965"/>
              <a:chExt cx="8477956" cy="2817531"/>
            </a:xfrm>
          </p:grpSpPr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96D40E17-B9DC-4EF9-9F99-C7B239C6334B}"/>
                  </a:ext>
                </a:extLst>
              </p:cNvPr>
              <p:cNvSpPr/>
              <p:nvPr/>
            </p:nvSpPr>
            <p:spPr>
              <a:xfrm>
                <a:off x="852425" y="905691"/>
                <a:ext cx="5928846" cy="2037805"/>
              </a:xfrm>
              <a:prstGeom prst="rect">
                <a:avLst/>
              </a:prstGeom>
              <a:noFill/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n w="38100">
                    <a:solidFill>
                      <a:schemeClr val="tx1"/>
                    </a:solidFill>
                  </a:ln>
                  <a:noFill/>
                </a:endParaRPr>
              </a:p>
            </p:txBody>
          </p:sp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E2E1325C-F9AE-4631-A614-80F05FE16272}"/>
                  </a:ext>
                </a:extLst>
              </p:cNvPr>
              <p:cNvGrpSpPr/>
              <p:nvPr/>
            </p:nvGrpSpPr>
            <p:grpSpPr>
              <a:xfrm>
                <a:off x="899890" y="125965"/>
                <a:ext cx="8430491" cy="2767463"/>
                <a:chOff x="1701078" y="456891"/>
                <a:chExt cx="8430491" cy="2767463"/>
              </a:xfrm>
            </p:grpSpPr>
            <p:grpSp>
              <p:nvGrpSpPr>
                <p:cNvPr id="14" name="Group 13">
                  <a:extLst>
                    <a:ext uri="{FF2B5EF4-FFF2-40B4-BE49-F238E27FC236}">
                      <a16:creationId xmlns:a16="http://schemas.microsoft.com/office/drawing/2014/main" id="{24CB4A51-43AE-4FA0-B624-2CD04F6675E1}"/>
                    </a:ext>
                  </a:extLst>
                </p:cNvPr>
                <p:cNvGrpSpPr/>
                <p:nvPr/>
              </p:nvGrpSpPr>
              <p:grpSpPr>
                <a:xfrm>
                  <a:off x="1701078" y="456891"/>
                  <a:ext cx="8430491" cy="2767463"/>
                  <a:chOff x="1571669" y="354908"/>
                  <a:chExt cx="8430491" cy="2767463"/>
                </a:xfrm>
              </p:grpSpPr>
              <p:grpSp>
                <p:nvGrpSpPr>
                  <p:cNvPr id="19" name="Group 18">
                    <a:extLst>
                      <a:ext uri="{FF2B5EF4-FFF2-40B4-BE49-F238E27FC236}">
                        <a16:creationId xmlns:a16="http://schemas.microsoft.com/office/drawing/2014/main" id="{788F2460-22CA-41FD-84CE-25BDE9853334}"/>
                      </a:ext>
                    </a:extLst>
                  </p:cNvPr>
                  <p:cNvGrpSpPr/>
                  <p:nvPr/>
                </p:nvGrpSpPr>
                <p:grpSpPr>
                  <a:xfrm>
                    <a:off x="1571669" y="354908"/>
                    <a:ext cx="5718628" cy="2767463"/>
                    <a:chOff x="2440085" y="1788012"/>
                    <a:chExt cx="5718628" cy="2767463"/>
                  </a:xfrm>
                </p:grpSpPr>
                <p:grpSp>
                  <p:nvGrpSpPr>
                    <p:cNvPr id="21" name="Group 20">
                      <a:extLst>
                        <a:ext uri="{FF2B5EF4-FFF2-40B4-BE49-F238E27FC236}">
                          <a16:creationId xmlns:a16="http://schemas.microsoft.com/office/drawing/2014/main" id="{9E78B33A-FBB6-42C4-95E0-670330A29AD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645777" y="1788012"/>
                      <a:ext cx="5512936" cy="2767463"/>
                      <a:chOff x="2553870" y="891029"/>
                      <a:chExt cx="6945673" cy="2767463"/>
                    </a:xfrm>
                  </p:grpSpPr>
                  <p:grpSp>
                    <p:nvGrpSpPr>
                      <p:cNvPr id="23" name="Group 22">
                        <a:extLst>
                          <a:ext uri="{FF2B5EF4-FFF2-40B4-BE49-F238E27FC236}">
                            <a16:creationId xmlns:a16="http://schemas.microsoft.com/office/drawing/2014/main" id="{6F51652E-03F5-4E67-99FB-DBF1E37403B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553870" y="891029"/>
                        <a:ext cx="5084587" cy="2767463"/>
                        <a:chOff x="1778807" y="803943"/>
                        <a:chExt cx="5084587" cy="2767463"/>
                      </a:xfrm>
                    </p:grpSpPr>
                    <p:grpSp>
                      <p:nvGrpSpPr>
                        <p:cNvPr id="30" name="Group 29">
                          <a:extLst>
                            <a:ext uri="{FF2B5EF4-FFF2-40B4-BE49-F238E27FC236}">
                              <a16:creationId xmlns:a16="http://schemas.microsoft.com/office/drawing/2014/main" id="{BC52EE72-25C5-4386-9C48-9BA310F282F6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778807" y="803943"/>
                          <a:ext cx="5084587" cy="2383390"/>
                          <a:chOff x="2202965" y="3276600"/>
                          <a:chExt cx="5084587" cy="2570925"/>
                        </a:xfrm>
                      </p:grpSpPr>
                      <p:grpSp>
                        <p:nvGrpSpPr>
                          <p:cNvPr id="34" name="Group 33">
                            <a:extLst>
                              <a:ext uri="{FF2B5EF4-FFF2-40B4-BE49-F238E27FC236}">
                                <a16:creationId xmlns:a16="http://schemas.microsoft.com/office/drawing/2014/main" id="{EC871AE6-017E-4D7E-A3BD-672B9C1A88AC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2202965" y="4739052"/>
                            <a:ext cx="5084587" cy="1108473"/>
                            <a:chOff x="727630" y="1000999"/>
                            <a:chExt cx="5084587" cy="864602"/>
                          </a:xfrm>
                        </p:grpSpPr>
                        <p:grpSp>
                          <p:nvGrpSpPr>
                            <p:cNvPr id="36" name="Group 35">
                              <a:extLst>
                                <a:ext uri="{FF2B5EF4-FFF2-40B4-BE49-F238E27FC236}">
                                  <a16:creationId xmlns:a16="http://schemas.microsoft.com/office/drawing/2014/main" id="{A8A97872-4DE9-4934-96A5-0A5EE9A4F115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727630" y="1000999"/>
                              <a:ext cx="5044315" cy="864602"/>
                              <a:chOff x="727630" y="1000999"/>
                              <a:chExt cx="5044315" cy="864602"/>
                            </a:xfrm>
                          </p:grpSpPr>
                          <p:grpSp>
                            <p:nvGrpSpPr>
                              <p:cNvPr id="38" name="Group 37">
                                <a:extLst>
                                  <a:ext uri="{FF2B5EF4-FFF2-40B4-BE49-F238E27FC236}">
                                    <a16:creationId xmlns:a16="http://schemas.microsoft.com/office/drawing/2014/main" id="{C37438FB-6E21-42A2-B743-F1F8D9E76533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727630" y="1000999"/>
                                <a:ext cx="2304971" cy="857271"/>
                                <a:chOff x="1019810" y="993739"/>
                                <a:chExt cx="2061178" cy="663687"/>
                              </a:xfrm>
                            </p:grpSpPr>
                            <p:sp>
                              <p:nvSpPr>
                                <p:cNvPr id="47" name="Chevron 6">
                                  <a:extLst>
                                    <a:ext uri="{FF2B5EF4-FFF2-40B4-BE49-F238E27FC236}">
                                      <a16:creationId xmlns:a16="http://schemas.microsoft.com/office/drawing/2014/main" id="{EE4FDF23-0384-4EDE-B0E7-A210432BF15C}"/>
                                    </a:ext>
                                  </a:extLst>
                                </p:cNvPr>
                                <p:cNvSpPr/>
                                <p:nvPr/>
                              </p:nvSpPr>
                              <p:spPr>
                                <a:xfrm>
                                  <a:off x="1019810" y="993739"/>
                                  <a:ext cx="1386172" cy="663687"/>
                                </a:xfrm>
                                <a:prstGeom prst="chevron">
                                  <a:avLst/>
                                </a:prstGeom>
                                <a:solidFill>
                                  <a:srgbClr val="05B34B"/>
                                </a:solidFill>
                                <a:ln>
                                  <a:solidFill>
                                    <a:srgbClr val="05B34B"/>
                                  </a:solidFill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>
                                  <a:defPPr>
                                    <a:defRPr lang="en-US"/>
                                  </a:defPPr>
                                  <a:lvl1pPr marL="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1pPr>
                                  <a:lvl2pPr marL="4572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2pPr>
                                  <a:lvl3pPr marL="9144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3pPr>
                                  <a:lvl4pPr marL="13716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4pPr>
                                  <a:lvl5pPr marL="18288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5pPr>
                                  <a:lvl6pPr marL="22860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6pPr>
                                  <a:lvl7pPr marL="27432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7pPr>
                                  <a:lvl8pPr marL="32004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8pPr>
                                  <a:lvl9pPr marL="36576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9pPr>
                                </a:lstStyle>
                                <a:p>
                                  <a:pPr algn="ctr"/>
                                  <a:endParaRPr lang="en-US" sz="1600" b="1" dirty="0">
                                    <a:solidFill>
                                      <a:srgbClr val="FFFF00"/>
                                    </a:solidFill>
                                    <a:latin typeface="Times New Roman" pitchFamily="18" charset="0"/>
                                    <a:cs typeface="Times New Roman" pitchFamily="18" charset="0"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48" name="TextBox 151">
                                  <a:extLst>
                                    <a:ext uri="{FF2B5EF4-FFF2-40B4-BE49-F238E27FC236}">
                                      <a16:creationId xmlns:a16="http://schemas.microsoft.com/office/drawing/2014/main" id="{D62EAB7D-4C5F-4E39-8740-FFB26612EDEF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1556989" y="1174698"/>
                                  <a:ext cx="1523999" cy="300716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>
                                  <a:defPPr>
                                    <a:defRPr lang="en-US"/>
                                  </a:defPPr>
                                  <a:lvl1pPr marL="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1pPr>
                                  <a:lvl2pPr marL="4572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2pPr>
                                  <a:lvl3pPr marL="9144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3pPr>
                                  <a:lvl4pPr marL="13716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4pPr>
                                  <a:lvl5pPr marL="18288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5pPr>
                                  <a:lvl6pPr marL="22860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6pPr>
                                  <a:lvl7pPr marL="27432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7pPr>
                                  <a:lvl8pPr marL="32004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8pPr>
                                  <a:lvl9pPr marL="36576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9pPr>
                                </a:lstStyle>
                                <a:p>
                                  <a:r>
                                    <a:rPr lang="en-US" sz="800" b="1" dirty="0">
                                      <a:latin typeface="Helvetica" panose="020B0604020202020204" pitchFamily="34" charset="0"/>
                                      <a:cs typeface="Helvetica" panose="020B0604020202020204" pitchFamily="34" charset="0"/>
                                    </a:rPr>
                                    <a:t>6 h</a:t>
                                  </a:r>
                                </a:p>
                                <a:p>
                                  <a:r>
                                    <a:rPr lang="en-US" sz="800" b="1" dirty="0">
                                      <a:latin typeface="Helvetica" panose="020B0604020202020204" pitchFamily="34" charset="0"/>
                                      <a:cs typeface="Helvetica" panose="020B0604020202020204" pitchFamily="34" charset="0"/>
                                    </a:rPr>
                                    <a:t>Appressoria </a:t>
                                  </a:r>
                                </a:p>
                                <a:p>
                                  <a:r>
                                    <a:rPr lang="en-US" sz="800" b="1" dirty="0">
                                      <a:latin typeface="Helvetica" panose="020B0604020202020204" pitchFamily="34" charset="0"/>
                                      <a:cs typeface="Helvetica" panose="020B0604020202020204" pitchFamily="34" charset="0"/>
                                    </a:rPr>
                                    <a:t>formation </a:t>
                                  </a:r>
                                </a:p>
                              </p:txBody>
                            </p:sp>
                          </p:grpSp>
                          <p:grpSp>
                            <p:nvGrpSpPr>
                              <p:cNvPr id="39" name="Group 38">
                                <a:extLst>
                                  <a:ext uri="{FF2B5EF4-FFF2-40B4-BE49-F238E27FC236}">
                                    <a16:creationId xmlns:a16="http://schemas.microsoft.com/office/drawing/2014/main" id="{D800B46E-A5AD-4FD5-A650-4E35182EDEA1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1733220" y="1001002"/>
                                <a:ext cx="2078093" cy="857273"/>
                                <a:chOff x="1859459" y="963280"/>
                                <a:chExt cx="1890438" cy="690335"/>
                              </a:xfrm>
                            </p:grpSpPr>
                            <p:sp>
                              <p:nvSpPr>
                                <p:cNvPr id="45" name="Chevron 8">
                                  <a:extLst>
                                    <a:ext uri="{FF2B5EF4-FFF2-40B4-BE49-F238E27FC236}">
                                      <a16:creationId xmlns:a16="http://schemas.microsoft.com/office/drawing/2014/main" id="{8D87F413-B361-45E9-BE92-2C19F525F690}"/>
                                    </a:ext>
                                  </a:extLst>
                                </p:cNvPr>
                                <p:cNvSpPr/>
                                <p:nvPr/>
                              </p:nvSpPr>
                              <p:spPr>
                                <a:xfrm>
                                  <a:off x="1859459" y="963280"/>
                                  <a:ext cx="1321640" cy="690335"/>
                                </a:xfrm>
                                <a:prstGeom prst="chevron">
                                  <a:avLst/>
                                </a:prstGeom>
                                <a:solidFill>
                                  <a:srgbClr val="05B34B"/>
                                </a:solidFill>
                                <a:ln>
                                  <a:solidFill>
                                    <a:srgbClr val="05B34B"/>
                                  </a:solidFill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>
                                  <a:defPPr>
                                    <a:defRPr lang="en-US"/>
                                  </a:defPPr>
                                  <a:lvl1pPr marL="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1pPr>
                                  <a:lvl2pPr marL="4572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2pPr>
                                  <a:lvl3pPr marL="9144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3pPr>
                                  <a:lvl4pPr marL="13716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4pPr>
                                  <a:lvl5pPr marL="18288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5pPr>
                                  <a:lvl6pPr marL="22860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6pPr>
                                  <a:lvl7pPr marL="27432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7pPr>
                                  <a:lvl8pPr marL="32004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8pPr>
                                  <a:lvl9pPr marL="3657600" algn="l" defTabSz="914400" rtl="0" eaLnBrk="1" latinLnBrk="0" hangingPunct="1">
                                    <a:defRPr sz="1800" kern="1200">
                                      <a:solidFill>
                                        <a:schemeClr val="lt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9pPr>
                                </a:lstStyle>
                                <a:p>
                                  <a:pPr algn="ctr"/>
                                  <a:endParaRPr lang="en-US" sz="1600" b="1" dirty="0">
                                    <a:solidFill>
                                      <a:srgbClr val="FFFF00"/>
                                    </a:solidFill>
                                    <a:latin typeface="Times New Roman" pitchFamily="18" charset="0"/>
                                    <a:cs typeface="Times New Roman" pitchFamily="18" charset="0"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46" name="TextBox 149">
                                  <a:extLst>
                                    <a:ext uri="{FF2B5EF4-FFF2-40B4-BE49-F238E27FC236}">
                                      <a16:creationId xmlns:a16="http://schemas.microsoft.com/office/drawing/2014/main" id="{A3BF8853-F6BB-45FA-965D-CE68BE937521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2322411" y="1106145"/>
                                  <a:ext cx="1427486" cy="479612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>
                                  <a:defPPr>
                                    <a:defRPr lang="en-US"/>
                                  </a:defPPr>
                                  <a:lvl1pPr marL="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1pPr>
                                  <a:lvl2pPr marL="4572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2pPr>
                                  <a:lvl3pPr marL="9144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3pPr>
                                  <a:lvl4pPr marL="13716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4pPr>
                                  <a:lvl5pPr marL="18288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5pPr>
                                  <a:lvl6pPr marL="22860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6pPr>
                                  <a:lvl7pPr marL="27432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7pPr>
                                  <a:lvl8pPr marL="32004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8pPr>
                                  <a:lvl9pPr marL="36576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9pPr>
                                </a:lstStyle>
                                <a:p>
                                  <a:r>
                                    <a:rPr lang="en-US" sz="800" b="1" dirty="0">
                                      <a:latin typeface="Helvetica" panose="020B0604020202020204" pitchFamily="34" charset="0"/>
                                      <a:cs typeface="Helvetica" panose="020B0604020202020204" pitchFamily="34" charset="0"/>
                                    </a:rPr>
                                    <a:t>12 h</a:t>
                                  </a:r>
                                </a:p>
                                <a:p>
                                  <a:r>
                                    <a:rPr lang="en-US" sz="800" b="1" dirty="0">
                                      <a:latin typeface="Helvetica" panose="020B0604020202020204" pitchFamily="34" charset="0"/>
                                      <a:cs typeface="Helvetica" panose="020B0604020202020204" pitchFamily="34" charset="0"/>
                                    </a:rPr>
                                    <a:t> Increased</a:t>
                                  </a:r>
                                </a:p>
                                <a:p>
                                  <a:r>
                                    <a:rPr lang="en-US" sz="800" b="1" dirty="0">
                                      <a:latin typeface="Helvetica" panose="020B0604020202020204" pitchFamily="34" charset="0"/>
                                      <a:cs typeface="Helvetica" panose="020B0604020202020204" pitchFamily="34" charset="0"/>
                                    </a:rPr>
                                    <a:t>appressoria</a:t>
                                  </a:r>
                                </a:p>
                                <a:p>
                                  <a:r>
                                    <a:rPr lang="en-US" sz="800" b="1" dirty="0">
                                      <a:latin typeface="Helvetica" panose="020B0604020202020204" pitchFamily="34" charset="0"/>
                                      <a:cs typeface="Helvetica" panose="020B0604020202020204" pitchFamily="34" charset="0"/>
                                    </a:rPr>
                                    <a:t>number</a:t>
                                  </a:r>
                                </a:p>
                                <a:p>
                                  <a:r>
                                    <a:rPr lang="en-US" sz="800" b="1" dirty="0">
                                      <a:latin typeface="Helvetica" panose="020B0604020202020204" pitchFamily="34" charset="0"/>
                                      <a:cs typeface="Helvetica" panose="020B0604020202020204" pitchFamily="34" charset="0"/>
                                    </a:rPr>
                                    <a:t>    </a:t>
                                  </a:r>
                                </a:p>
                              </p:txBody>
                            </p:sp>
                          </p:grpSp>
                          <p:sp>
                            <p:nvSpPr>
                              <p:cNvPr id="40" name="Chevron 14">
                                <a:extLst>
                                  <a:ext uri="{FF2B5EF4-FFF2-40B4-BE49-F238E27FC236}">
                                    <a16:creationId xmlns:a16="http://schemas.microsoft.com/office/drawing/2014/main" id="{C4245D7B-78FA-415A-8FBB-1377205598D7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2636744" y="1008329"/>
                                <a:ext cx="1411813" cy="849945"/>
                              </a:xfrm>
                              <a:prstGeom prst="chevron">
                                <a:avLst/>
                              </a:prstGeom>
                              <a:solidFill>
                                <a:srgbClr val="05B34B"/>
                              </a:solidFill>
                              <a:ln>
                                <a:solidFill>
                                  <a:srgbClr val="05B34B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>
                                <a:defPPr>
                                  <a:defRPr lang="en-US"/>
                                </a:defPPr>
                                <a:lvl1pPr marL="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1pPr>
                                <a:lvl2pPr marL="4572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2pPr>
                                <a:lvl3pPr marL="9144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3pPr>
                                <a:lvl4pPr marL="13716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4pPr>
                                <a:lvl5pPr marL="18288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5pPr>
                                <a:lvl6pPr marL="22860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6pPr>
                                <a:lvl7pPr marL="27432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7pPr>
                                <a:lvl8pPr marL="32004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8pPr>
                                <a:lvl9pPr marL="36576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9pPr>
                              </a:lstStyle>
                              <a:p>
                                <a:pPr algn="ctr"/>
                                <a:endParaRPr lang="en-US" b="1" dirty="0">
                                  <a:solidFill>
                                    <a:schemeClr val="tx1"/>
                                  </a:solidFill>
                                  <a:latin typeface="Arial" pitchFamily="34" charset="0"/>
                                  <a:cs typeface="Arial" pitchFamily="34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41" name="TextBox 144">
                                <a:extLst>
                                  <a:ext uri="{FF2B5EF4-FFF2-40B4-BE49-F238E27FC236}">
                                    <a16:creationId xmlns:a16="http://schemas.microsoft.com/office/drawing/2014/main" id="{305E0DCC-AD07-42AF-959C-332FA7C46EBE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3056232" y="1242314"/>
                                <a:ext cx="1057810" cy="284848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square" rtlCol="0">
                                <a:spAutoFit/>
                              </a:bodyPr>
                              <a:lstStyle>
                                <a:defPPr>
                                  <a:defRPr lang="en-US"/>
                                </a:defPPr>
                                <a:lvl1pPr marL="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1pPr>
                                <a:lvl2pPr marL="4572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2pPr>
                                <a:lvl3pPr marL="9144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3pPr>
                                <a:lvl4pPr marL="13716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4pPr>
                                <a:lvl5pPr marL="18288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5pPr>
                                <a:lvl6pPr marL="22860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6pPr>
                                <a:lvl7pPr marL="27432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7pPr>
                                <a:lvl8pPr marL="32004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8pPr>
                                <a:lvl9pPr marL="36576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9pPr>
                              </a:lstStyle>
                              <a:p>
                                <a:r>
                                  <a:rPr lang="en-US" sz="800" b="1" dirty="0">
                                    <a:latin typeface="Helvetica" panose="020B0604020202020204" pitchFamily="34" charset="0"/>
                                    <a:cs typeface="Helvetica" panose="020B0604020202020204" pitchFamily="34" charset="0"/>
                                  </a:rPr>
                                  <a:t>    24 h</a:t>
                                </a:r>
                              </a:p>
                              <a:p>
                                <a:r>
                                  <a:rPr lang="en-US" sz="800" b="1" dirty="0">
                                    <a:latin typeface="Helvetica" panose="020B0604020202020204" pitchFamily="34" charset="0"/>
                                    <a:cs typeface="Helvetica" panose="020B0604020202020204" pitchFamily="34" charset="0"/>
                                  </a:rPr>
                                  <a:t>   Penetration </a:t>
                                </a:r>
                              </a:p>
                            </p:txBody>
                          </p:sp>
                          <p:sp>
                            <p:nvSpPr>
                              <p:cNvPr id="42" name="Chevron 18">
                                <a:extLst>
                                  <a:ext uri="{FF2B5EF4-FFF2-40B4-BE49-F238E27FC236}">
                                    <a16:creationId xmlns:a16="http://schemas.microsoft.com/office/drawing/2014/main" id="{B2F0FA78-CBCC-42D3-855F-22A7D56AEC72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3508928" y="1015655"/>
                                <a:ext cx="1351031" cy="842617"/>
                              </a:xfrm>
                              <a:prstGeom prst="chevron">
                                <a:avLst/>
                              </a:prstGeom>
                              <a:solidFill>
                                <a:srgbClr val="05B34B"/>
                              </a:solidFill>
                              <a:ln>
                                <a:solidFill>
                                  <a:srgbClr val="05B34B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>
                                <a:defPPr>
                                  <a:defRPr lang="en-US"/>
                                </a:defPPr>
                                <a:lvl1pPr marL="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1pPr>
                                <a:lvl2pPr marL="4572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2pPr>
                                <a:lvl3pPr marL="9144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3pPr>
                                <a:lvl4pPr marL="13716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4pPr>
                                <a:lvl5pPr marL="18288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5pPr>
                                <a:lvl6pPr marL="22860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6pPr>
                                <a:lvl7pPr marL="27432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7pPr>
                                <a:lvl8pPr marL="32004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8pPr>
                                <a:lvl9pPr marL="36576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9pPr>
                              </a:lstStyle>
                              <a:p>
                                <a:pPr algn="ctr"/>
                                <a:endParaRPr lang="en-US" b="1" dirty="0">
                                  <a:solidFill>
                                    <a:schemeClr val="tx1"/>
                                  </a:solidFill>
                                  <a:latin typeface="Arial" pitchFamily="34" charset="0"/>
                                  <a:cs typeface="Arial" pitchFamily="34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43" name="TextBox 146">
                                <a:extLst>
                                  <a:ext uri="{FF2B5EF4-FFF2-40B4-BE49-F238E27FC236}">
                                    <a16:creationId xmlns:a16="http://schemas.microsoft.com/office/drawing/2014/main" id="{4A87DFD4-6843-4BAB-95C6-F7C29F25D94F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3993826" y="1234837"/>
                                <a:ext cx="804897" cy="388429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square" rtlCol="0">
                                <a:spAutoFit/>
                              </a:bodyPr>
                              <a:lstStyle>
                                <a:defPPr>
                                  <a:defRPr lang="en-US"/>
                                </a:defPPr>
                                <a:lvl1pPr marL="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1pPr>
                                <a:lvl2pPr marL="4572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2pPr>
                                <a:lvl3pPr marL="9144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3pPr>
                                <a:lvl4pPr marL="13716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4pPr>
                                <a:lvl5pPr marL="18288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5pPr>
                                <a:lvl6pPr marL="22860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6pPr>
                                <a:lvl7pPr marL="27432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7pPr>
                                <a:lvl8pPr marL="32004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8pPr>
                                <a:lvl9pPr marL="36576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9pPr>
                              </a:lstStyle>
                              <a:p>
                                <a:r>
                                  <a:rPr lang="en-US" sz="800" b="1" dirty="0">
                                    <a:latin typeface="Helvetica" panose="020B0604020202020204" pitchFamily="34" charset="0"/>
                                    <a:cs typeface="Helvetica" panose="020B0604020202020204" pitchFamily="34" charset="0"/>
                                  </a:rPr>
                                  <a:t> 48 h</a:t>
                                </a:r>
                              </a:p>
                              <a:p>
                                <a:r>
                                  <a:rPr lang="en-US" sz="800" b="1" dirty="0">
                                    <a:latin typeface="Helvetica" panose="020B0604020202020204" pitchFamily="34" charset="0"/>
                                    <a:cs typeface="Helvetica" panose="020B0604020202020204" pitchFamily="34" charset="0"/>
                                  </a:rPr>
                                  <a:t> Infection </a:t>
                                </a:r>
                              </a:p>
                              <a:p>
                                <a:r>
                                  <a:rPr lang="en-US" sz="800" b="1" dirty="0">
                                    <a:latin typeface="Helvetica" panose="020B0604020202020204" pitchFamily="34" charset="0"/>
                                    <a:cs typeface="Helvetica" panose="020B0604020202020204" pitchFamily="34" charset="0"/>
                                  </a:rPr>
                                  <a:t>vesicles</a:t>
                                </a:r>
                              </a:p>
                            </p:txBody>
                          </p:sp>
                          <p:sp>
                            <p:nvSpPr>
                              <p:cNvPr id="44" name="Chevron 20">
                                <a:extLst>
                                  <a:ext uri="{FF2B5EF4-FFF2-40B4-BE49-F238E27FC236}">
                                    <a16:creationId xmlns:a16="http://schemas.microsoft.com/office/drawing/2014/main" id="{3DBF4BF7-826B-493F-B466-8FEFE5410A84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4308616" y="1015658"/>
                                <a:ext cx="1463329" cy="849943"/>
                              </a:xfrm>
                              <a:prstGeom prst="chevron">
                                <a:avLst/>
                              </a:prstGeom>
                              <a:solidFill>
                                <a:srgbClr val="05B34B"/>
                              </a:solidFill>
                              <a:ln>
                                <a:solidFill>
                                  <a:srgbClr val="05B34B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>
                                <a:defPPr>
                                  <a:defRPr lang="en-US"/>
                                </a:defPPr>
                                <a:lvl1pPr marL="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1pPr>
                                <a:lvl2pPr marL="4572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2pPr>
                                <a:lvl3pPr marL="9144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3pPr>
                                <a:lvl4pPr marL="13716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4pPr>
                                <a:lvl5pPr marL="18288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5pPr>
                                <a:lvl6pPr marL="22860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6pPr>
                                <a:lvl7pPr marL="27432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7pPr>
                                <a:lvl8pPr marL="32004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8pPr>
                                <a:lvl9pPr marL="3657600" algn="l" defTabSz="914400" rtl="0" eaLnBrk="1" latinLnBrk="0" hangingPunct="1">
                                  <a:defRPr sz="1800" kern="1200">
                                    <a:solidFill>
                                      <a:schemeClr val="lt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9pPr>
                              </a:lstStyle>
                              <a:p>
                                <a:pPr algn="ctr"/>
                                <a:endParaRPr lang="en-US" b="1" dirty="0">
                                  <a:solidFill>
                                    <a:schemeClr val="tx1"/>
                                  </a:solidFill>
                                  <a:latin typeface="Arial" pitchFamily="34" charset="0"/>
                                  <a:cs typeface="Arial" pitchFamily="34" charset="0"/>
                                </a:endParaRPr>
                              </a:p>
                            </p:txBody>
                          </p:sp>
                        </p:grpSp>
                        <p:sp>
                          <p:nvSpPr>
                            <p:cNvPr id="37" name="TextBox 140">
                              <a:extLst>
                                <a:ext uri="{FF2B5EF4-FFF2-40B4-BE49-F238E27FC236}">
                                  <a16:creationId xmlns:a16="http://schemas.microsoft.com/office/drawing/2014/main" id="{9765F09A-0B8D-4037-8068-AB7F8999C6CD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839466" y="1141441"/>
                              <a:ext cx="972751" cy="595592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>
                              <a:defPPr>
                                <a:defRPr lang="en-US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r>
                                <a:rPr lang="en-US" sz="800" b="1" dirty="0">
                                  <a:latin typeface="Helvetica" panose="020B0604020202020204" pitchFamily="34" charset="0"/>
                                  <a:cs typeface="Helvetica" panose="020B0604020202020204" pitchFamily="34" charset="0"/>
                                </a:rPr>
                                <a:t>  72 h</a:t>
                              </a:r>
                            </a:p>
                            <a:p>
                              <a:r>
                                <a:rPr lang="en-US" sz="800" b="1" dirty="0">
                                  <a:latin typeface="Helvetica" panose="020B0604020202020204" pitchFamily="34" charset="0"/>
                                  <a:cs typeface="Helvetica" panose="020B0604020202020204" pitchFamily="34" charset="0"/>
                                </a:rPr>
                                <a:t> Infection vesicles</a:t>
                              </a:r>
                            </a:p>
                            <a:p>
                              <a:r>
                                <a:rPr lang="en-US" sz="800" b="1" dirty="0">
                                  <a:latin typeface="Helvetica" panose="020B0604020202020204" pitchFamily="34" charset="0"/>
                                  <a:cs typeface="Helvetica" panose="020B0604020202020204" pitchFamily="34" charset="0"/>
                                </a:rPr>
                                <a:t> and hyphae</a:t>
                              </a:r>
                            </a:p>
                          </p:txBody>
                        </p:sp>
                      </p:grpSp>
                      <p:sp>
                        <p:nvSpPr>
                          <p:cNvPr id="35" name="AutoShape 4" descr="data:image/jpeg;base64,/9j/4AAQSkZJRgABAQAAAQABAAD/2wCEAAkGBwgHBgkIBwgKCgkLDRYPDQwMDRsUFRAWIB0iIiAdHx8kKDQsJCYxJx8fLT0tMTU3Ojo6Iys/RD84QzQ5OjcBCgoKDQwNGg8PGjclHyU3Nzc3Nzc3Nzc3Nzc3Nzc3Nzc3Nzc3Nzc3Nzc3Nzc3Nzc3Nzc3Nzc3Nzc3Nzc3Nzc3N//AABEIAHgAeAMBIgACEQEDEQH/xAAcAAABBQEBAQAAAAAAAAAAAAAAAwQFBgcBAgj/xAA9EAACAQMDAgQDBQYDCQEAAAABAgMABBEFEiExQQYTUWEicYEUMpGh8AcjM0LB4VKx0RViY2RygqKy8ST/xAAaAQACAwEBAAAAAAAAAAAAAAAABAIDBQEG/8QAKxEAAgIBAwMDAQkAAAAAAAAAAAECEQMEEiETMUEFIlHxIzIzQmFxgaGx/9oADAMBAAIRAxEAPwDcaKKKACiiigAooooAK4xwDmu1F+I7prXSZ2jJErjYmB3P6NRnJRi2wIm40I+I7oXmpTt9iGfIgjOMr6k+9ermTwr4Qi3PFaWznkYQNK3v6/U0h4h8RL4f8LI9qUlvdiRRoBkByOpx9Tj2qo+E9J1O4vm1iezTUb523K90/wC7hPXcT/i9MZ28dKWeVWlHuwS4NCtNTvtQt/Ps9Pkjib7huBsZh67Tg/jXVu9XilAksjKnfaFH4HNISapr9v8AxNCinH/K3ik/+YWuJ4h1Bl58Oagh9G2/0NW18thRPSSrFE0khCqoySe1FvL50KS7Su9Q2D1Gag4zqGqzhb2zktrVSCVcj4vbg81PqMCpxbZw7RRRUzoUU3c3EbEhVlU9ADtI/wBfypNryVcD7Dck/wDZj/2rl0A8oqOa9vDgx6bKQf8AFIq4/OozW9eu9ItTc3cFvDHnA3S5JPoAOSflUXkS5AsE88VvGZJ5FjQdWc4AqKvtc8mNXtrWSZXOEboG+XeqAdduPE88lwkC+Xb9DcSGOMHsFUZJP6JFSNu06lpprh2kAHQ8D/SksurfaB2Sce5aI9YupIgxihRmOPjyAvzqOvhJOyS3l6kuwn92rgDrngCmEk088zNLnfwOeOPXn+1V9ruQ+MntxKDGbcZwc9O/5/nSGTJPJGnK/wCiKd9h9JbNqGo2zXzKlmsm91UbsL7f5fWrLe+JbW1tnh0y1lMcC/yRbQB/ug4zTeONGOMcenof0KQ1bTLfULKWBuGZSFK9j2Nc02onjTRPHKO5KfYlPD/ijR9RRAl3suW6xXA2N9M1ZQ2RxXzhdW627SIsiSE/AwMIGHU8jByRgjr360+0DxdrOgThI7h5rY4LQOcjA7rnpxmtXHqU+JGtm9Le3fido+gq7WfWP7R7W7Em0EPEcOnsejj1U8YPvz7vD41WTCwgZNMb4mVLHKLpoumRnFFR+iySXFv58pyzUVNECRrnFdry5Cgk9BQBFa7rUejKklxbTyQtxvi2nB9ME5/Csu17Un1/WBJNeRrAPhRG3LsX0xjHp1zUp4k1mG61qG9kZpLWMlBEOy4J6e+Pz9qp97aNJIyQEsAu/wCFSCq4549Oe/tWXqMrk6T4NrSaDPFqcWuV5RO6r4itrCFbHTCZZs7TK2SF7d+Sa8+DbmR7yeC8dnNxhlZjn4hnj+v0qv2trEsuJCu5gR5j/wAp65/XrT0q9qyFNyT4D+hXIyPyI/Gkm7do0l6RDpyhJ3N+TTNuxsjGNozkc9f71j+o6i8nim61G1bG18RErnIHH59fr2qy6r4quV0uSBkCXLLt3j37j3qvmyktdPjdIg0d5Hy+PulWzwfX1q5O7pGfoPTp45PrL9C96D4httRg2sTHIB8Snpn0zU2LkbQpIyVyp9f71jawyPMDGCMEEsM/AM9fYUpqV3qctzJFBfzmMyMscaTEr1wNp75qp4lJ8MhqfR2p/ZvgX1S8C6jqizWUeJbgvBOYhuxjBAbuDgHHPemstzIojkgu9jbvMAikYFWHTrzkZPI9a8Xtyz6PbpJK80yzMGYjkqFGD65+LH0pO4iSJ0aNg0csfmJiQMV9iR3BFNO6/Yf0alGGyaO2V59hu4ZpVZhASRjsh+8pHdT+R5rYbHQbO5iSe2AMbDdx/lWLSksCZCxTbyw7DgfXHHFaZ+zLWG0/zrO7clJpg6E9ACq9Pb/SmtO+KYj6njX3kaVpS+VH5fYCinse1gGTGDyCKKcMU903v5BFZzyEAhY2PPypxTDW7eS70i8t4mKySQsqkepFcl2ZKFblZikkSLaSs0hSVHzIr98EgkD05FeTdTW7TAjm4G2YOMkqCDgHtxj8KcXMDRXBXUFdEeBVLd1O0DHzzzTa7eW4umS5kJnGBnH3jgAfTAFYbVHu4VJU+V9DtnHFJqEUVzlUaUCQjnAJpeSDE80PlsXjcuX/AOGuckn8KRlvTM8gWOOJGcSHA+JWHHX6n8qeWF8qCdLzf5F5EYjKF5XHQj1wQKjBRb2stm8lb6/gcabZWOv3AtdQ8yzuCpaORVysi+m09+Dgio+8uri9tokghKaZafu41z93uxJ7sepr3eXjRXS3QvEmmXAjMQICgf8AV+uaa2k9tbl5ZlnZgwb7MDiNzz94+ntj1phT/K+H5FOnL8Tv8L4+RG6hSwvZdPuVO6Odo3mBxmP5fPn61DFY97fG20ZKso74OPlzin9+9xcTfbbncXumZw5/mIPxEfU4pqUjaPzA+4DAkQnB3HPQdxgDn3qtSvhE6pK3y/8ATutG3lv3ez2tG6IxZE2jOwbuO3OeO1MQzRnseMYYZHTFKSK8ZYHKPjH0Iz+YP516vbs3c8s7xIrykcJ0XAxgD8Km3bspraqE3EUNoLqRt6uJEeEDG08BSSQQcls9P5anFkm0yz08O8jtJI86FjztcIR/WoO2igeRvtMkXkSR+WxXJOXHGMj7w6n3FPtbuzPc2sZyDFDsORjo7Dp8gB8gKbxr2mLrZXKjcPBGtLqmmhWb97GBkd8UVVP2Tki9lBLYMXTt1opqDtGRNVI1CuEV2ipkDLfG2myw62VQkW9x/IVyAx+6w9s8H0+Rqs3UbzXEcIVxdIi7pgCVHufbPetl1zSo9UtwrkrJHkow9xgj9elZD9nNkZnaWdFjnMbZYq2O6MvpwD15/Gs7Ph91/J6P07VuWPb5RG3UkYupVZNhLH4yTx6cUlcTZKwqZNkYxtkxw383TtnP64pZmEkjtJInlNhUZOHcMcfUDuD6ikJWkR2Mq+am7LsAMkf060nKCo2o5eefAXJhBQwuTmMFsrjDHqMf1rl3I13cyz7t7MvmO2Dgcc9u3Skp3CzASb3G1QNzZ2j0+QpGRHLMYg+1gVx04z3z24HWubDvUqn5Fku5o7SW0jiDmQgMxXcVAJOF9OpzTGaF0iV2Bw44IAI6kc+hyD88Guy70/dsAMENz1+n4/lRJNcC1jgJXy43LLEMbmc9yOp7D5fOrYq+5ROVO4+RMz7WT7QhO1cZHDH0JPfHA+QxXiTHl7AEaVnwOoI6YYHjg+9cEsZ4ZEJLcAA4APXGDx/eupBBI7RJvMxRgMgBcYzu9gKsjG2LZMiiiT8PQ2st5AocSxWwe5uJVUlA3w7R09V+tRGpX51LV57pM7Hc7OOSM9T7nr9ad2uqC28NXcRjEQuCqxKqfE2ScszfIHAHA+oqOsIyzjAOKcXEaMPNLdNs2H9kMUhFxKR+7VAvPrRU/wDs0057Hw+GkGGmfePljiiroKomfN3IttFFFTInMVSvHekXT77uxNskcsYjuC6DOc/CeevXFXavE0aSoySKGVhgg9xUJwU1RbhyvFNSRghNtb20aXW2OXeWKNkgnplSARimlrJkzyiCQSbQuI3IxnocHqD6fI1PeK9EuNPu7mJbVdgk8yMAlgyHPxDnIOcZGagLqS5ht4WjgRUKYDNksvPQ81nSSXDPU459SKkvI2upEjJBSN0ycbSDt9jikZ2SR02XBZ5MEq2evz6fjSgKIh/gyIyY8vcc7uT0+Z7U2kieNkdpYFbaki7BkAHoOO47io0ixyYqI9kCSyRLKquIy2/uegAHU00cPGTJI8YlMmOMOwPfjPYA8HvXpJGLE4QySdCkS7hnoBgZJPSkNrwphZWhTgMu7Y3yOO9TSRTJy8i+6V7uOJrAPcbRlTkMc9DgYx17iiC5ms55hAnmwlxDtQ4EzHtnrj29xXRa3c0sY2PhWB3Agg4xyem7+mKdfaLqzBN6izTQRuY92AsJY4UqoA5PJ55wKuihPNKlyMNeuIbu/SO1WJIYo1j2xfc3AAHHqOAB8qsXgfQG1bUkgEZ2dXb0FQGh6ZJdTxxRRM7sQoHXNfQ3hPQItD09Ywo89xmQj1q5LczJySpExbQpbwRwxjCooUfSilaKvFQooooAK5iu0UAV3xtoo1jRZVjt1luYxui+LaT6jNZLqNmluYpZkJwm5gigSqRnAw2OORnvxW9mqV448NiZ/wDa9muJFXFygXPmIO/z+Xals+O/cjS0GqWN9OXYyFtqo0sUXwlgfiX7vyPcUmYixGEhAZd4xg9yO3yPBqUlQ+XI9gZvLX4IwdpU5OeOPc1G3KZjX97E2ByI9uWPofTFI7Wj0G9NcDd5jJMptfhJbevlZXHcAE88cYr3DNLDdQz7IGdHP8cB97kZ+IdTjPU8Z/CvMallLbESNMk5yQTj1749BTi1eKR8sqIC+0TrEMluOR3/APtWRtspyNRR40mGO61CPZKFiQANO2Qx+98I9AeT9M8UmIkvr0WlgHeBGwDj+Ic8se5NPzaOpksbYoI2bOU67SOhPckdfwrSfAHgmOxEWoXQ+McohH50xCL7GPqcyvgf+APCsel2i3d3F/8AqY8Aj7o7VdaKKaSpGY227YUUUV04FFFFABRRRQAVxhkYNFFAGd+MfCrQO19pu2K3+9LGB8I9eP61n7afCTIYAxwdyk4K5OO/40UUplglI2NFnm4u32EBYPJMYrmfdcKN6QAZCkjvTqFGQeTNGLq5XKoEBKx7uwx1ODRRUVFIlqM0qo0PwJ4RMMf+0NZtyLpzlI37e5Hr7VfgAKKKbikkY8pOTtnaKKKkRCiiigD/2Q==">
                            <a:extLst>
                              <a:ext uri="{FF2B5EF4-FFF2-40B4-BE49-F238E27FC236}">
                                <a16:creationId xmlns:a16="http://schemas.microsoft.com/office/drawing/2014/main" id="{0D1D5FD1-A331-4BB7-B4BD-28806193843E}"/>
                              </a:ext>
                            </a:extLst>
                          </p:cNvPr>
                          <p:cNvSpPr>
                            <a:spLocks noChangeAspect="1" noChangeArrowheads="1"/>
                          </p:cNvSpPr>
                          <p:nvPr/>
                        </p:nvSpPr>
                        <p:spPr bwMode="auto">
                          <a:xfrm>
                            <a:off x="5943600" y="3276600"/>
                            <a:ext cx="304800" cy="304800"/>
                          </a:xfrm>
                          <a:prstGeom prst="rect">
                            <a:avLst/>
                          </a:prstGeom>
                          <a:noFill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</a:extLst>
                        </p:spPr>
                        <p:txBody>
                          <a:bodyPr vert="horz" wrap="square" lIns="91440" tIns="45720" rIns="91440" bIns="45720" numCol="1" anchor="t" anchorCtr="0" compatLnSpc="1">
                            <a:prstTxWarp prst="textNoShape">
                              <a:avLst/>
                            </a:prstTxWarp>
                          </a:bodyPr>
                          <a:lstStyle>
                            <a:defPPr>
                              <a:defRPr lang="en-US"/>
                            </a:defPPr>
                            <a:lvl1pPr marL="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1pPr>
                            <a:lvl2pPr marL="4572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2pPr>
                            <a:lvl3pPr marL="9144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3pPr>
                            <a:lvl4pPr marL="13716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4pPr>
                            <a:lvl5pPr marL="18288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5pPr>
                            <a:lvl6pPr marL="22860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6pPr>
                            <a:lvl7pPr marL="27432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7pPr>
                            <a:lvl8pPr marL="32004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8pPr>
                            <a:lvl9pPr marL="36576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9pPr>
                          </a:lstStyle>
                          <a:p>
                            <a:endParaRPr lang="en-US"/>
                          </a:p>
                        </p:txBody>
                      </p:sp>
                    </p:grpSp>
                    <p:sp>
                      <p:nvSpPr>
                        <p:cNvPr id="31" name="TextBox 128">
                          <a:extLst>
                            <a:ext uri="{FF2B5EF4-FFF2-40B4-BE49-F238E27FC236}">
                              <a16:creationId xmlns:a16="http://schemas.microsoft.com/office/drawing/2014/main" id="{630819FF-480B-4891-9E06-4B27B8855E0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241682" y="3294407"/>
                          <a:ext cx="1386938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>
                          <a:spAutoFit/>
                        </a:bodyPr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r>
                            <a:rPr lang="en-US" sz="1200" b="1" dirty="0">
                              <a:solidFill>
                                <a:srgbClr val="FF00FF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Biotrophic</a:t>
                          </a:r>
                          <a:endParaRPr lang="en-US" sz="1200" dirty="0">
                            <a:solidFill>
                              <a:srgbClr val="FF00FF"/>
                            </a:solidFill>
                            <a:latin typeface="Helvetica" panose="020B0604020202020204" pitchFamily="34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2" name="TextBox 129">
                          <a:extLst>
                            <a:ext uri="{FF2B5EF4-FFF2-40B4-BE49-F238E27FC236}">
                              <a16:creationId xmlns:a16="http://schemas.microsoft.com/office/drawing/2014/main" id="{DC718082-2B32-406C-BF93-AE2B6E5867D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614195" y="3267462"/>
                          <a:ext cx="1657589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>
                          <a:spAutoFit/>
                        </a:bodyPr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r>
                            <a:rPr lang="en-US" sz="1200" b="1" dirty="0" err="1">
                              <a:solidFill>
                                <a:srgbClr val="0000FF"/>
                              </a:solidFill>
                              <a:effectLst>
                                <a:outerShdw blurRad="38100" dist="38100" dir="2700000" algn="tl">
                                  <a:srgbClr val="000000">
                                    <a:alpha val="43137"/>
                                  </a:srgbClr>
                                </a:outerShdw>
                              </a:effectLst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Hemibiotrophic</a:t>
                          </a:r>
                          <a:endParaRPr lang="en-US" sz="1200" b="1" dirty="0">
                            <a:solidFill>
                              <a:srgbClr val="0000FF"/>
                            </a:solidFill>
                            <a:effectLst>
                              <a:outerShdw blurRad="38100" dist="38100" dir="2700000" algn="tl">
                                <a:srgbClr val="000000">
                                  <a:alpha val="43137"/>
                                </a:srgbClr>
                              </a:outerShdw>
                            </a:effectLst>
                            <a:latin typeface="Helvetica" panose="020B0604020202020204" pitchFamily="34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3" name="TextBox 131">
                          <a:extLst>
                            <a:ext uri="{FF2B5EF4-FFF2-40B4-BE49-F238E27FC236}">
                              <a16:creationId xmlns:a16="http://schemas.microsoft.com/office/drawing/2014/main" id="{F778BF1E-D285-42E5-BB44-38B389BD126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213812" y="3268279"/>
                          <a:ext cx="1438361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>
                          <a:defPPr>
                            <a:defRPr lang="en-US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r>
                            <a:rPr lang="en-US" sz="1200" b="1" dirty="0">
                              <a:solidFill>
                                <a:srgbClr val="FF0000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Necrotrophic</a:t>
                          </a:r>
                        </a:p>
                      </p:txBody>
                    </p:sp>
                  </p:grpSp>
                  <p:pic>
                    <p:nvPicPr>
                      <p:cNvPr id="24" name="Picture 23" descr="Image result for strawberry fruit rot disease">
                        <a:extLst>
                          <a:ext uri="{FF2B5EF4-FFF2-40B4-BE49-F238E27FC236}">
                            <a16:creationId xmlns:a16="http://schemas.microsoft.com/office/drawing/2014/main" id="{8EBE9309-554B-4F7C-A467-2931F302F856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381969" y="2690949"/>
                        <a:ext cx="1117574" cy="809896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  <a:prstDash val="solid"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  <p:pic>
                    <p:nvPicPr>
                      <p:cNvPr id="25" name="Picture 24" descr="Image result for photos of strawberry anthracnose leaves">
                        <a:extLst>
                          <a:ext uri="{FF2B5EF4-FFF2-40B4-BE49-F238E27FC236}">
                            <a16:creationId xmlns:a16="http://schemas.microsoft.com/office/drawing/2014/main" id="{1D6EFC6A-B20C-4793-8FFB-3EA2673BAD9E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336525" y="1741716"/>
                        <a:ext cx="1120678" cy="818604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  <p:sp>
                    <p:nvSpPr>
                      <p:cNvPr id="26" name="Arrow: Right 25">
                        <a:extLst>
                          <a:ext uri="{FF2B5EF4-FFF2-40B4-BE49-F238E27FC236}">
                            <a16:creationId xmlns:a16="http://schemas.microsoft.com/office/drawing/2014/main" id="{52028A37-5466-4AFF-B9EB-3ACFD1E06FFC}"/>
                          </a:ext>
                        </a:extLst>
                      </p:cNvPr>
                      <p:cNvSpPr/>
                      <p:nvPr/>
                    </p:nvSpPr>
                    <p:spPr>
                      <a:xfrm rot="20512881">
                        <a:off x="7065016" y="2149381"/>
                        <a:ext cx="1210572" cy="72861"/>
                      </a:xfrm>
                      <a:prstGeom prst="rightArrow">
                        <a:avLst/>
                      </a:prstGeom>
                      <a:solidFill>
                        <a:schemeClr val="tx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>
                          <a:ln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27" name="Arrow: Right 26">
                        <a:extLst>
                          <a:ext uri="{FF2B5EF4-FFF2-40B4-BE49-F238E27FC236}">
                            <a16:creationId xmlns:a16="http://schemas.microsoft.com/office/drawing/2014/main" id="{570CEAEA-A75F-4F35-8697-1C08CEEC978B}"/>
                          </a:ext>
                        </a:extLst>
                      </p:cNvPr>
                      <p:cNvSpPr/>
                      <p:nvPr/>
                    </p:nvSpPr>
                    <p:spPr>
                      <a:xfrm rot="1087574">
                        <a:off x="7352871" y="3050888"/>
                        <a:ext cx="1022229" cy="71814"/>
                      </a:xfrm>
                      <a:prstGeom prst="rightArrow">
                        <a:avLst/>
                      </a:prstGeom>
                      <a:solidFill>
                        <a:schemeClr val="tx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lt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endParaRPr lang="en-US">
                          <a:ln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28" name="TextBox 125">
                        <a:extLst>
                          <a:ext uri="{FF2B5EF4-FFF2-40B4-BE49-F238E27FC236}">
                            <a16:creationId xmlns:a16="http://schemas.microsoft.com/office/drawing/2014/main" id="{6B17254B-C27F-4F1E-BD0A-DA5A17CA9220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20555969">
                        <a:off x="6840851" y="1966734"/>
                        <a:ext cx="1464268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r>
                          <a:rPr lang="en-US" sz="800" b="1" i="1" dirty="0">
                            <a:effectLst/>
                            <a:latin typeface="Helvetica" panose="020B0604020202020204" pitchFamily="34" charset="0"/>
                            <a:cs typeface="Helvetica" panose="020B0604020202020204" pitchFamily="34" charset="0"/>
                          </a:rPr>
                          <a:t>C. </a:t>
                        </a:r>
                        <a:r>
                          <a:rPr lang="en-US" sz="800" b="1" i="1" dirty="0" err="1">
                            <a:effectLst/>
                            <a:latin typeface="Helvetica" panose="020B0604020202020204" pitchFamily="34" charset="0"/>
                            <a:cs typeface="Helvetica" panose="020B0604020202020204" pitchFamily="34" charset="0"/>
                          </a:rPr>
                          <a:t>gloeosporioides</a:t>
                        </a:r>
                        <a:endPara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9" name="TextBox 126">
                        <a:extLst>
                          <a:ext uri="{FF2B5EF4-FFF2-40B4-BE49-F238E27FC236}">
                            <a16:creationId xmlns:a16="http://schemas.microsoft.com/office/drawing/2014/main" id="{8FE21001-1BCC-4554-B518-33658B6A116E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180039">
                        <a:off x="7419008" y="2869854"/>
                        <a:ext cx="1014436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>
                        <a:defPPr>
                          <a:defRPr lang="en-US"/>
                        </a:defPPr>
                        <a:lvl1pPr marL="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9144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r>
                          <a:rPr lang="en-US" sz="800" b="1" i="1" dirty="0">
                            <a:solidFill>
                              <a:srgbClr val="333333"/>
                            </a:solidFill>
                            <a:effectLst/>
                            <a:latin typeface="Helvetica" panose="020B0604020202020204" pitchFamily="34" charset="0"/>
                            <a:cs typeface="Helvetica" panose="020B0604020202020204" pitchFamily="34" charset="0"/>
                          </a:rPr>
                          <a:t>C. </a:t>
                        </a:r>
                        <a:r>
                          <a:rPr lang="en-US" sz="800" b="1" i="1" dirty="0" err="1">
                            <a:effectLst/>
                            <a:latin typeface="Helvetica" panose="020B0604020202020204" pitchFamily="34" charset="0"/>
                            <a:cs typeface="Helvetica" panose="020B0604020202020204" pitchFamily="34" charset="0"/>
                          </a:rPr>
                          <a:t>acutatum</a:t>
                        </a:r>
                        <a:endPara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22" name="TextBox 152">
                      <a:extLst>
                        <a:ext uri="{FF2B5EF4-FFF2-40B4-BE49-F238E27FC236}">
                          <a16:creationId xmlns:a16="http://schemas.microsoft.com/office/drawing/2014/main" id="{563A6123-8BCE-4656-AB6B-1115C172A96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40085" y="2603518"/>
                      <a:ext cx="332142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en-US" sz="16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</a:t>
                      </a:r>
                    </a:p>
                  </p:txBody>
                </p:sp>
              </p:grpSp>
              <p:sp>
                <p:nvSpPr>
                  <p:cNvPr id="20" name="TextBox 21">
                    <a:extLst>
                      <a:ext uri="{FF2B5EF4-FFF2-40B4-BE49-F238E27FC236}">
                        <a16:creationId xmlns:a16="http://schemas.microsoft.com/office/drawing/2014/main" id="{869AC4C2-EDD2-445C-9FC4-A5E862439506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079209" y="1351296"/>
                    <a:ext cx="922951" cy="33746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800" b="1" dirty="0">
                        <a:solidFill>
                          <a:srgbClr val="0000CC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 </a:t>
                    </a:r>
                    <a:r>
                      <a:rPr lang="en-US" altLang="en-US" sz="800" b="1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Paraquat </a:t>
                    </a:r>
                  </a:p>
                  <a:p>
                    <a:pPr algn="ctr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800" b="1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bio-assay</a:t>
                    </a:r>
                  </a:p>
                </p:txBody>
              </p:sp>
            </p:grpSp>
            <p:grpSp>
              <p:nvGrpSpPr>
                <p:cNvPr id="15" name="Group 14">
                  <a:extLst>
                    <a:ext uri="{FF2B5EF4-FFF2-40B4-BE49-F238E27FC236}">
                      <a16:creationId xmlns:a16="http://schemas.microsoft.com/office/drawing/2014/main" id="{04F1DDF1-58F4-4D39-8DBA-C548A662845C}"/>
                    </a:ext>
                  </a:extLst>
                </p:cNvPr>
                <p:cNvGrpSpPr/>
                <p:nvPr/>
              </p:nvGrpSpPr>
              <p:grpSpPr>
                <a:xfrm>
                  <a:off x="1881051" y="2855857"/>
                  <a:ext cx="3762104" cy="105057"/>
                  <a:chOff x="1881051" y="2855857"/>
                  <a:chExt cx="3762104" cy="105057"/>
                </a:xfrm>
              </p:grpSpPr>
              <p:sp>
                <p:nvSpPr>
                  <p:cNvPr id="16" name="Arrow: Left-Right 15">
                    <a:extLst>
                      <a:ext uri="{FF2B5EF4-FFF2-40B4-BE49-F238E27FC236}">
                        <a16:creationId xmlns:a16="http://schemas.microsoft.com/office/drawing/2014/main" id="{0448A073-2407-45FD-B84C-8E663EC1E16D}"/>
                      </a:ext>
                    </a:extLst>
                  </p:cNvPr>
                  <p:cNvSpPr/>
                  <p:nvPr/>
                </p:nvSpPr>
                <p:spPr>
                  <a:xfrm>
                    <a:off x="1881051" y="2864566"/>
                    <a:ext cx="1471748" cy="96348"/>
                  </a:xfrm>
                  <a:prstGeom prst="leftRightArrow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n>
                        <a:solidFill>
                          <a:sysClr val="windowText" lastClr="000000"/>
                        </a:solidFill>
                      </a:ln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17" name="Arrow: Left-Right 16">
                    <a:extLst>
                      <a:ext uri="{FF2B5EF4-FFF2-40B4-BE49-F238E27FC236}">
                        <a16:creationId xmlns:a16="http://schemas.microsoft.com/office/drawing/2014/main" id="{FC4CAE39-A8B4-44AC-A318-A557BA7140F9}"/>
                      </a:ext>
                    </a:extLst>
                  </p:cNvPr>
                  <p:cNvSpPr/>
                  <p:nvPr/>
                </p:nvSpPr>
                <p:spPr>
                  <a:xfrm>
                    <a:off x="3370212" y="2860212"/>
                    <a:ext cx="1297583" cy="91994"/>
                  </a:xfrm>
                  <a:prstGeom prst="leftRightArrow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n>
                        <a:solidFill>
                          <a:sysClr val="windowText" lastClr="000000"/>
                        </a:solidFill>
                      </a:ln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18" name="Arrow: Left-Right 17">
                    <a:extLst>
                      <a:ext uri="{FF2B5EF4-FFF2-40B4-BE49-F238E27FC236}">
                        <a16:creationId xmlns:a16="http://schemas.microsoft.com/office/drawing/2014/main" id="{247C40F7-8899-4E39-9A47-1FA63266900F}"/>
                      </a:ext>
                    </a:extLst>
                  </p:cNvPr>
                  <p:cNvSpPr/>
                  <p:nvPr/>
                </p:nvSpPr>
                <p:spPr>
                  <a:xfrm>
                    <a:off x="4685212" y="2855857"/>
                    <a:ext cx="957943" cy="105057"/>
                  </a:xfrm>
                  <a:prstGeom prst="leftRightArrow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n>
                        <a:solidFill>
                          <a:sysClr val="windowText" lastClr="000000"/>
                        </a:solidFill>
                      </a:ln>
                      <a:solidFill>
                        <a:sysClr val="windowText" lastClr="000000"/>
                      </a:solidFill>
                    </a:endParaRPr>
                  </a:p>
                </p:txBody>
              </p:sp>
            </p:grpSp>
          </p:grpSp>
        </p:grpSp>
        <p:pic>
          <p:nvPicPr>
            <p:cNvPr id="6" name="Picture 5" descr="This is a 30 minute clip of us spraying a bottle of water. #ASMR #MP3Sounds  #Spraybottle | How to make terrariums, Homemade flea spray, Spray bottle">
              <a:extLst>
                <a:ext uri="{FF2B5EF4-FFF2-40B4-BE49-F238E27FC236}">
                  <a16:creationId xmlns:a16="http://schemas.microsoft.com/office/drawing/2014/main" id="{8B5FBD40-A61C-4704-ABF0-00438B951FA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215311" y="1034967"/>
              <a:ext cx="1062445" cy="88601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5721D7F-09C3-4E8D-943B-0FFB2119A3D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0800000">
              <a:off x="9331038" y="986496"/>
              <a:ext cx="1549009" cy="11333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TextBox 19">
              <a:extLst>
                <a:ext uri="{FF2B5EF4-FFF2-40B4-BE49-F238E27FC236}">
                  <a16:creationId xmlns:a16="http://schemas.microsoft.com/office/drawing/2014/main" id="{B1CCCE54-E71C-4683-AFC7-F089A17F51F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058957" y="1688128"/>
              <a:ext cx="838517" cy="337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en-US" sz="800" b="1" dirty="0">
                  <a:solidFill>
                    <a:srgbClr val="FFFF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RNA for </a:t>
              </a:r>
            </a:p>
            <a:p>
              <a:pPr algn="ctr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en-US" sz="800" b="1" dirty="0">
                  <a:solidFill>
                    <a:srgbClr val="FFFF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RNA-Seq</a:t>
              </a:r>
            </a:p>
          </p:txBody>
        </p:sp>
        <p:sp>
          <p:nvSpPr>
            <p:cNvPr id="9" name="TextBox 20">
              <a:extLst>
                <a:ext uri="{FF2B5EF4-FFF2-40B4-BE49-F238E27FC236}">
                  <a16:creationId xmlns:a16="http://schemas.microsoft.com/office/drawing/2014/main" id="{44A82B25-EE41-4A25-AB69-6BFDB1AAAF9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318040" y="1699338"/>
              <a:ext cx="731935" cy="3374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en-US" sz="8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DNA for qPCR</a:t>
              </a:r>
            </a:p>
          </p:txBody>
        </p:sp>
        <p:sp>
          <p:nvSpPr>
            <p:cNvPr id="10" name="TextBox 21">
              <a:extLst>
                <a:ext uri="{FF2B5EF4-FFF2-40B4-BE49-F238E27FC236}">
                  <a16:creationId xmlns:a16="http://schemas.microsoft.com/office/drawing/2014/main" id="{D72E1FF1-FAC4-4E7D-BE1F-75A0A38854A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599257" y="1223318"/>
              <a:ext cx="922957" cy="337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en-US" sz="800" b="1" dirty="0">
                  <a:solidFill>
                    <a:srgbClr val="0000CC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n-US" altLang="en-US" sz="8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Paraquat </a:t>
              </a:r>
            </a:p>
            <a:p>
              <a:pPr algn="ctr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en-US" sz="8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bio-assay</a:t>
              </a:r>
            </a:p>
          </p:txBody>
        </p:sp>
        <p:sp>
          <p:nvSpPr>
            <p:cNvPr id="11" name="TextBox 152">
              <a:extLst>
                <a:ext uri="{FF2B5EF4-FFF2-40B4-BE49-F238E27FC236}">
                  <a16:creationId xmlns:a16="http://schemas.microsoft.com/office/drawing/2014/main" id="{7DFD7D2B-16B5-4B51-B153-B83C29D172CB}"/>
                </a:ext>
              </a:extLst>
            </p:cNvPr>
            <p:cNvSpPr txBox="1"/>
            <p:nvPr/>
          </p:nvSpPr>
          <p:spPr>
            <a:xfrm>
              <a:off x="7785713" y="908625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6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B</a:t>
              </a:r>
            </a:p>
          </p:txBody>
        </p:sp>
      </p:grpSp>
      <p:sp>
        <p:nvSpPr>
          <p:cNvPr id="57" name="TextBox 56">
            <a:extLst>
              <a:ext uri="{FF2B5EF4-FFF2-40B4-BE49-F238E27FC236}">
                <a16:creationId xmlns:a16="http://schemas.microsoft.com/office/drawing/2014/main" id="{0BC4280C-2F42-43C5-8E65-C8365D7BDDF4}"/>
              </a:ext>
            </a:extLst>
          </p:cNvPr>
          <p:cNvSpPr txBox="1"/>
          <p:nvPr/>
        </p:nvSpPr>
        <p:spPr>
          <a:xfrm>
            <a:off x="9426820" y="213494"/>
            <a:ext cx="193835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Adhikari et al.</a:t>
            </a:r>
          </a:p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Front. Genetics</a:t>
            </a:r>
          </a:p>
          <a:p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31662502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86</Words>
  <Application>Microsoft Office PowerPoint</Application>
  <PresentationFormat>Widescreen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Arial Narrow</vt:lpstr>
      <vt:lpstr>Calibri</vt:lpstr>
      <vt:lpstr>Calibri Light</vt:lpstr>
      <vt:lpstr>Helvetic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ka</dc:creator>
  <cp:lastModifiedBy>Tika</cp:lastModifiedBy>
  <cp:revision>2</cp:revision>
  <dcterms:created xsi:type="dcterms:W3CDTF">2021-12-12T14:27:11Z</dcterms:created>
  <dcterms:modified xsi:type="dcterms:W3CDTF">2021-12-12T20:53:24Z</dcterms:modified>
</cp:coreProperties>
</file>